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3"/>
  </p:normalViewPr>
  <p:slideViewPr>
    <p:cSldViewPr snapToGrid="0" snapToObjects="1">
      <p:cViewPr varScale="1">
        <p:scale>
          <a:sx n="123" d="100"/>
          <a:sy n="123" d="100"/>
        </p:scale>
        <p:origin x="80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03B9A43-C5AF-0741-BFB9-E32DD0377C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="" xmlns:a16="http://schemas.microsoft.com/office/drawing/2014/main" id="{2C867690-B595-FE4B-A916-1DF560821F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E8AF11A2-2438-4F4B-A67D-8FAAA949D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BC688B5E-19D4-9F4D-BFF1-9C91D264C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508D32C3-D8F8-3343-9DC5-21F497B150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93365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4ABA85A-AE2F-4149-A2AF-DD3E192CC3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C7ECC175-7A3F-324C-8DFE-BA1EC12F92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44494510-11BB-A140-9743-E5DC123B2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32B0A960-D008-5D40-9F29-B0E107660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0831EAB2-1C51-3345-918D-7C10A3334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175688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="" xmlns:a16="http://schemas.microsoft.com/office/drawing/2014/main" id="{C0102CFC-74F6-EC4C-9FF4-1DEBEFFA7B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E7F0FA73-1610-F24B-BA9A-A7D15A29EE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34ADBBB-D1CF-0245-B349-FFDF26ADA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043E5D58-8EF5-9D40-8703-B5D8750C2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7B2189D1-39B6-BD40-8C79-28766EFE1C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6598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E2DA2104-C14A-5843-A07C-0231DED4B1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13489A6-145F-9E40-8CFA-A885312F06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B3F468DB-F0A4-4043-8865-EFD0FE48D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086F598E-FD7D-BB4D-A12E-694C792CA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09C683F5-48A7-6B46-B8BF-BB346584B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80584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251A077-50F4-6B40-8089-6DA43666BA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F31457EC-DFAD-264B-9031-D910F8D52B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031BD898-8064-3D4F-9E9B-C75B15812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461F090-E3E4-B84C-B776-F28CA6543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4DD68F0F-9298-1040-B66D-F014BAF45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995463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97DC9055-D1EA-5E4A-AE41-57BB8EA29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15F1FB56-9D56-F34A-B5F6-2121A3317D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FE395EC3-92F1-6046-992B-8C44F058F6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32F753B7-0BDB-EF4E-8488-37C6117C5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8F80F89C-84D5-2747-8DD3-E12309E80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E6BDC829-D7C4-0045-89B9-44210D608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866499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6AE7F793-AEC2-B246-8668-D3E8528BC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96582490-D485-5749-A975-AD2B2748FE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3CD4208C-B7F7-EC40-B942-96A4EA92AD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="" xmlns:a16="http://schemas.microsoft.com/office/drawing/2014/main" id="{F12C2F13-8D36-0F4A-870C-D316452AEC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="" xmlns:a16="http://schemas.microsoft.com/office/drawing/2014/main" id="{BF66DDC6-B088-4C46-8551-3939BC5AFD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="" xmlns:a16="http://schemas.microsoft.com/office/drawing/2014/main" id="{166C2FA9-D828-4946-914C-9852C8301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="" xmlns:a16="http://schemas.microsoft.com/office/drawing/2014/main" id="{A3A7D2D8-9235-C24F-B161-24DD0DEC3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="" xmlns:a16="http://schemas.microsoft.com/office/drawing/2014/main" id="{4AFADCC9-F507-E541-AE67-5B0FAB9D0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005819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C2DC5765-6C68-5A43-B812-8BF62DF52F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="" xmlns:a16="http://schemas.microsoft.com/office/drawing/2014/main" id="{9CF2C96D-4B4B-E446-B61B-4EFCFA65D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="" xmlns:a16="http://schemas.microsoft.com/office/drawing/2014/main" id="{31E3FD99-26F9-3340-AD55-73712E937A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="" xmlns:a16="http://schemas.microsoft.com/office/drawing/2014/main" id="{64011E21-AA14-0F4A-8516-20BF2020FE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74651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="" xmlns:a16="http://schemas.microsoft.com/office/drawing/2014/main" id="{879618BF-C6DD-494F-8FB2-03EB4185C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="" xmlns:a16="http://schemas.microsoft.com/office/drawing/2014/main" id="{C4AE5E4C-BD39-DE41-ABE3-84AEF8D9D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="" xmlns:a16="http://schemas.microsoft.com/office/drawing/2014/main" id="{03E95593-4061-D341-9C2E-505943B37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19990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B5C0E384-BFD0-D14E-813B-B610988F6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94D7E92E-DCCA-8B48-BE59-10973DC3B6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05DAE1DD-F99A-CF44-9907-B5086C65A9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3791C2E9-909A-4443-BB43-3AD676CAC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7A142BEA-0289-044F-ABCC-BB6250BBC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DCAF7283-45D6-F244-A052-EBF66B9F8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58624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867E3A1-D54F-A64E-BFF7-6BD7542271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="" xmlns:a16="http://schemas.microsoft.com/office/drawing/2014/main" id="{A01303BB-C29B-0449-A29D-6DECD80604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493D4BCF-0A2B-6B49-BE1D-98E04B42B0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E1242A6E-768F-F048-AE27-ADBE1B7D0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7C3B28BC-207A-164A-AC69-97B481C69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74C90D61-FF1E-3248-956F-5A4F861E9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55098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5DA992B9-4C5D-5847-8C6E-6396697528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6D1F65FE-4D94-654F-BB31-7F4A47D035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471A72B2-2518-8B49-9B3F-4143C54CA0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07D11-D53C-C840-9008-9C6383009974}" type="datetimeFigureOut">
              <a:rPr lang="en-US"/>
              <a:pPr/>
              <a:t>8/19/2020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5BC9C57-3562-1043-AFB1-9D2ACA3E9B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D3A27AD1-F8F0-3741-8E31-38474CA1CC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F74EE-C5A9-AE42-8657-BF717CA59D1D}" type="slidenum">
              <a:rPr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105396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Рисунок 33">
            <a:extLst>
              <a:ext uri="{FF2B5EF4-FFF2-40B4-BE49-F238E27FC236}">
                <a16:creationId xmlns="" xmlns:a16="http://schemas.microsoft.com/office/drawing/2014/main" id="{2B41F9FE-AC06-564E-9C20-A77CB16A3E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00" y="409767"/>
            <a:ext cx="11582400" cy="1955800"/>
          </a:xfrm>
          <a:prstGeom prst="rect">
            <a:avLst/>
          </a:prstGeom>
        </p:spPr>
      </p:pic>
      <p:pic>
        <p:nvPicPr>
          <p:cNvPr id="21" name="Рисунок 10">
            <a:extLst>
              <a:ext uri="{FF2B5EF4-FFF2-40B4-BE49-F238E27FC236}">
                <a16:creationId xmlns="" xmlns:a16="http://schemas.microsoft.com/office/drawing/2014/main" id="{38E2AEB4-8DA8-6244-81E4-E3CF073D9F6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4710"/>
          <a:stretch/>
        </p:blipFill>
        <p:spPr>
          <a:xfrm>
            <a:off x="2673721" y="3412059"/>
            <a:ext cx="5859615" cy="1916791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8FAEAD85-BF07-1847-A446-EBD029955050}"/>
              </a:ext>
            </a:extLst>
          </p:cNvPr>
          <p:cNvSpPr txBox="1"/>
          <p:nvPr/>
        </p:nvSpPr>
        <p:spPr>
          <a:xfrm>
            <a:off x="2721655" y="2981221"/>
            <a:ext cx="62994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Contig of length 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6602 </a:t>
            </a:r>
            <a:r>
              <a:rPr lang="en-US" sz="2000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US" sz="2000" i="1" dirty="0" smtClean="0">
                <a:latin typeface="Times New Roman" pitchFamily="18" charset="0"/>
                <a:cs typeface="Times New Roman" pitchFamily="18" charset="0"/>
              </a:rPr>
              <a:t>SAT::2A::</a:t>
            </a:r>
            <a:r>
              <a:rPr lang="en-US" sz="2000" i="1" dirty="0" err="1" smtClean="0">
                <a:latin typeface="Times New Roman" pitchFamily="18" charset="0"/>
                <a:cs typeface="Times New Roman" pitchFamily="18" charset="0"/>
              </a:rPr>
              <a:t>mCHERRY</a:t>
            </a:r>
            <a:r>
              <a:rPr lang="en-US" sz="20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insert </a:t>
            </a:r>
            <a:endParaRPr lang="ru-RU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Открывающая фигурная скобка 4">
            <a:extLst>
              <a:ext uri="{FF2B5EF4-FFF2-40B4-BE49-F238E27FC236}">
                <a16:creationId xmlns="" xmlns:a16="http://schemas.microsoft.com/office/drawing/2014/main" id="{E923EDF8-8A5F-D345-9A71-9852ED1538D3}"/>
              </a:ext>
            </a:extLst>
          </p:cNvPr>
          <p:cNvSpPr/>
          <p:nvPr/>
        </p:nvSpPr>
        <p:spPr>
          <a:xfrm rot="16200000">
            <a:off x="5884090" y="4838132"/>
            <a:ext cx="227262" cy="1164312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DA136C20-DEB4-7941-9120-DA16BFD47A8B}"/>
              </a:ext>
            </a:extLst>
          </p:cNvPr>
          <p:cNvSpPr txBox="1"/>
          <p:nvPr/>
        </p:nvSpPr>
        <p:spPr>
          <a:xfrm>
            <a:off x="5415565" y="5644492"/>
            <a:ext cx="110107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SAT::2A::</a:t>
            </a:r>
          </a:p>
          <a:p>
            <a:r>
              <a:rPr lang="en-US" sz="1600" i="1" dirty="0" err="1" smtClean="0">
                <a:latin typeface="Times New Roman" pitchFamily="18" charset="0"/>
                <a:cs typeface="Times New Roman" pitchFamily="18" charset="0"/>
              </a:rPr>
              <a:t>mCHERRY</a:t>
            </a:r>
            <a:endParaRPr lang="en-US" sz="1600" i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sequence </a:t>
            </a:r>
            <a:endParaRPr lang="ru-RU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Открывающая фигурная скобка 6">
            <a:extLst>
              <a:ext uri="{FF2B5EF4-FFF2-40B4-BE49-F238E27FC236}">
                <a16:creationId xmlns="" xmlns:a16="http://schemas.microsoft.com/office/drawing/2014/main" id="{4E0D1D40-8C51-2A49-B1F0-354A8DFA93FC}"/>
              </a:ext>
            </a:extLst>
          </p:cNvPr>
          <p:cNvSpPr/>
          <p:nvPr/>
        </p:nvSpPr>
        <p:spPr>
          <a:xfrm rot="16200000">
            <a:off x="7116526" y="4838133"/>
            <a:ext cx="227262" cy="1164312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6AAA7ED3-EBFB-684A-81D8-5A637702D1A0}"/>
              </a:ext>
            </a:extLst>
          </p:cNvPr>
          <p:cNvSpPr txBox="1"/>
          <p:nvPr/>
        </p:nvSpPr>
        <p:spPr>
          <a:xfrm>
            <a:off x="6629721" y="5648049"/>
            <a:ext cx="233910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ts to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ishmania</a:t>
            </a:r>
          </a:p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 with</a:t>
            </a:r>
          </a:p>
          <a:p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TUBULIN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notations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Открывающая фигурная скобка 8">
            <a:extLst>
              <a:ext uri="{FF2B5EF4-FFF2-40B4-BE49-F238E27FC236}">
                <a16:creationId xmlns="" xmlns:a16="http://schemas.microsoft.com/office/drawing/2014/main" id="{19B94E1B-BFD2-514A-A0EC-26BF99A8EDB5}"/>
              </a:ext>
            </a:extLst>
          </p:cNvPr>
          <p:cNvSpPr/>
          <p:nvPr/>
        </p:nvSpPr>
        <p:spPr>
          <a:xfrm rot="16200000">
            <a:off x="3945954" y="4104552"/>
            <a:ext cx="177189" cy="2625786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646D82BF-4B5E-AE40-BB85-BB7E6C5C68F3}"/>
              </a:ext>
            </a:extLst>
          </p:cNvPr>
          <p:cNvSpPr txBox="1"/>
          <p:nvPr/>
        </p:nvSpPr>
        <p:spPr>
          <a:xfrm>
            <a:off x="3042794" y="5648049"/>
            <a:ext cx="26938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ts to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ishmani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omosomes with</a:t>
            </a:r>
          </a:p>
          <a:p>
            <a:r>
              <a:rPr lang="en-US" sz="16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-TUBULIN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notations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1459406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32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Тема Offic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Gerasimov Evgeny</dc:creator>
  <cp:lastModifiedBy>yurchenko</cp:lastModifiedBy>
  <cp:revision>16</cp:revision>
  <dcterms:created xsi:type="dcterms:W3CDTF">2020-05-04T08:52:53Z</dcterms:created>
  <dcterms:modified xsi:type="dcterms:W3CDTF">2020-08-19T10:36:37Z</dcterms:modified>
</cp:coreProperties>
</file>